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4750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479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046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102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4353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5670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3536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11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381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777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90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924CD-92B4-4D6D-92E3-B3813C63B0CD}" type="datetimeFigureOut">
              <a:rPr lang="en-GB" smtClean="0"/>
              <a:t>31/07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26505-D1A9-4BAD-AA58-F88035250B5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5814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/>
          <p:cNvSpPr/>
          <p:nvPr/>
        </p:nvSpPr>
        <p:spPr>
          <a:xfrm>
            <a:off x="370936" y="6016486"/>
            <a:ext cx="11481757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quency, in North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outh-Western and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uth-Eastern Mediterranean, of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types assigned to the five genetic clusters and the admixed 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 identified by 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UCTURE analysi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7211" y="189781"/>
            <a:ext cx="4651223" cy="5296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7883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DZ-Forum.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6</cp:revision>
  <dcterms:created xsi:type="dcterms:W3CDTF">2019-04-29T13:19:35Z</dcterms:created>
  <dcterms:modified xsi:type="dcterms:W3CDTF">2019-07-31T07:39:59Z</dcterms:modified>
</cp:coreProperties>
</file>